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7A1BC-F798-41DB-968E-DEE307C022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52FEFE-FF0B-466A-81CA-812170EBBB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C51D3D-2327-4D59-95C0-1DE453172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541A0E-6E06-45B6-BBE7-27E974D6C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9110E3-95A5-4849-BC7C-BE7709634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0085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D44B3-22FD-4210-865C-477BE72CC7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F21038-E808-4587-8F46-E1DB11BCC1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6EE5C0-21FE-4CE0-A3A7-1F65E998D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FB608E-5813-4372-916F-F151672E3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90BD16-8D10-4E94-99FE-C105C6512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8467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C36590-F921-403A-854E-DD70894A9E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85C3DA-4C0A-46EE-9FAE-FBC252CDFB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8FCD32-E182-478C-A144-22BBF9B64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0D8C19-E3FC-4E63-98B2-2B56874FC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B98A0F-9917-4EE1-858A-A4BCEBAC4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8651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3E26E4-4E83-4C1A-B883-54F52A3847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CE13DE-F65C-4EC9-999F-8546FA61E8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24CF3F-9DBD-46CE-9E61-C0379839D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CD4FB-352F-439A-80DB-AFCA527BD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C8A269-767F-4193-B51B-95644E89D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470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12F90-A546-42C0-A026-D702784A92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DC4268-2F3E-4FDB-B308-37D985431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F9CAD-25A7-4821-85BE-CEFB16DFA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59D786-F352-42BA-AD96-2B91D568F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A9243-1740-4E08-BB68-2FA29102A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206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3393CE-5CE1-4D98-B071-1C1AA174BB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7D89F4-FC81-4A00-A141-12CD012D0C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E69EDF-8429-420A-8642-29A687AD61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4CE7B0-7F0F-4FF2-B930-D5078E59F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662B36-7151-4A39-8B3A-706B1ECE9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951CF4-F4E1-4BCA-8382-64E8C7099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2560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A9369C-421C-4C77-87FC-7A7BDBC4C4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3659F0-4DE8-4F8F-8EA9-481F9F8346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F4CDB5-0D66-4B67-A1D7-6F5F6DFC51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A55EBC-EB34-4ECD-99DE-43227FCCDE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F4DC8C-6420-462A-9D63-51B88297D5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954FED-30D4-4E46-BAE8-5FC6DE2F7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44198A4-0B2C-4B31-B119-B4F6174A4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B8CC927-DDB1-44A9-BAB0-0D44AFDB0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8549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B40700-8307-4621-B7B4-2DE65A189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334298-9983-4D84-85F5-670B4511A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0E0146-91B7-414C-96E7-74C103D38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D851179-F2ED-4E2D-8AA5-C6378D1DB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044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A7CFD0-1165-4B26-AB60-8A0B77B20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1D1173-004C-4870-949B-D033E9EDC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2DA364-77FE-42F5-A581-655F4206E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7094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E60F75-5B5B-4603-94BC-84CDF867E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F7D00B-F448-4CFF-8E02-9225C84712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18AB4C-8308-410A-9FCA-FF54A971D5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13C824-513F-4FF8-ABA9-834590D1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230B71-9DB1-47DB-B155-0BDCD5A42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AE9304-BB81-47BD-958E-F611B8ECE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746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8C54D2-7BC6-4358-A3E4-FE64BD0C5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DC9083-B821-43BC-B71B-BC74470D4C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02942F-06DC-4CAC-9A16-C80310767C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5DFB58-3757-4782-9D68-AE781E227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3F8EE9-943B-4A01-9690-E6004A28A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E04AE2-F0C1-41F5-8B15-B019C9BCE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8177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790434-761A-4D24-AEA9-F21C3442B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5FB1F3-904F-4C23-9572-EB0AD4EED8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449C92-DD55-401A-83D8-963FDBC71F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E3F62-E09F-4B7D-A26B-4649DAC73D53}" type="datetimeFigureOut">
              <a:rPr lang="en-GB" smtClean="0"/>
              <a:t>19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BFC143-FB69-4310-A2E8-8B00345944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282828-A353-4AA3-8CBC-957EB31330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8AAB80-054B-47E1-8C01-B1E0D08E2B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6636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polioeradication.org/gpei-budget-2022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polioeradication.org/gpei-budget-2022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D916691E-AE76-479B-9E21-D638E0BB9579}"/>
              </a:ext>
            </a:extLst>
          </p:cNvPr>
          <p:cNvSpPr/>
          <p:nvPr/>
        </p:nvSpPr>
        <p:spPr>
          <a:xfrm>
            <a:off x="322555" y="300061"/>
            <a:ext cx="11324948" cy="7396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sz="2000" b="1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Figure S3</a:t>
            </a:r>
            <a:r>
              <a:rPr lang="en-US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GPEI activity-specific budget (log10 transformed) in the period 2018 to 2022 in polio transition priority countries </a:t>
            </a:r>
            <a:r>
              <a:rPr lang="en-GB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y implementing agency WHO (</a:t>
            </a:r>
            <a:r>
              <a:rPr lang="en-GB" sz="2000" b="1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 UNICEF (</a:t>
            </a:r>
            <a:r>
              <a:rPr lang="en-GB" sz="2000" b="1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A60C1B7-9D8E-4578-906D-2931B1FE4D96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266" t="27855" r="-135" b="30650"/>
          <a:stretch/>
        </p:blipFill>
        <p:spPr bwMode="auto">
          <a:xfrm>
            <a:off x="6915704" y="1086443"/>
            <a:ext cx="2614850" cy="213159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D49DE10-DCE2-485C-965E-20152E4D2620}"/>
              </a:ext>
            </a:extLst>
          </p:cNvPr>
          <p:cNvSpPr/>
          <p:nvPr/>
        </p:nvSpPr>
        <p:spPr>
          <a:xfrm>
            <a:off x="6915704" y="3264730"/>
            <a:ext cx="5157927" cy="3323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finitions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“Campaigns – SIAs” includes the oral polio vaccine procurement, campaign operational costs, and campaign social mobilization costs. “Non-campaign immunization activities” include the community-based vaccination costs and others. “Surveillance” incorporates costs for laboratory, technical assistance, and other surveillance and running costs. “Core functions &amp; Infrastructure” includes ongoing quality improvements, communications, engagement, and social mobilization costs, and technical assistance. “OPV Withdrawal – SWITCH” covers research and product development as well as stockpiles for emergency response (OPV2), and technical assistance for oral polio vaccine withdrawal. </a:t>
            </a:r>
          </a:p>
          <a:p>
            <a:pPr algn="just"/>
            <a:r>
              <a:rPr lang="en-US" sz="14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ronym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OPV = oral polio vaccine; SIA = supplementary immunization activity. </a:t>
            </a:r>
          </a:p>
          <a:p>
            <a:pPr algn="just"/>
            <a:r>
              <a:rPr lang="en-US" sz="14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urce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GPEI budget 2022 – Available at </a:t>
            </a:r>
            <a:r>
              <a:rPr lang="en-US" sz="1400" u="sng" dirty="0">
                <a:solidFill>
                  <a:srgbClr val="0000FF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polioeradication.org/</a:t>
            </a:r>
            <a:br>
              <a:rPr lang="en-US" sz="1400" u="sng" dirty="0">
                <a:solidFill>
                  <a:srgbClr val="0000FF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</a:br>
            <a:r>
              <a:rPr lang="en-US" sz="1400" u="sng" dirty="0">
                <a:solidFill>
                  <a:srgbClr val="0000FF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gpei-budget-2022/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ata provided by GPEI). </a:t>
            </a:r>
            <a:endParaRPr lang="en-GB" sz="14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167EEDB-4D39-4C8A-815F-8054CAC6D54F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46229" y="1316099"/>
            <a:ext cx="6480000" cy="493378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565762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D916691E-AE76-479B-9E21-D638E0BB9579}"/>
              </a:ext>
            </a:extLst>
          </p:cNvPr>
          <p:cNvSpPr/>
          <p:nvPr/>
        </p:nvSpPr>
        <p:spPr>
          <a:xfrm>
            <a:off x="322555" y="300061"/>
            <a:ext cx="11324948" cy="7396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sz="2000" b="1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Figure S3</a:t>
            </a:r>
            <a:r>
              <a:rPr lang="en-US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GPEI activity-specific budget (log10 transformed) in the period 2018 to 2022 in polio transition priority countries </a:t>
            </a:r>
            <a:r>
              <a:rPr lang="en-GB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y implementing agency WHO (</a:t>
            </a:r>
            <a:r>
              <a:rPr lang="en-GB" sz="2000" b="1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 UNICEF (</a:t>
            </a:r>
            <a:r>
              <a:rPr lang="en-GB" sz="2000" b="1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2000" dirty="0">
                <a:latin typeface="Garamond" panose="02020404030301010803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A60C1B7-9D8E-4578-906D-2931B1FE4D96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266" t="27855" r="-135" b="30650"/>
          <a:stretch/>
        </p:blipFill>
        <p:spPr bwMode="auto">
          <a:xfrm>
            <a:off x="6915704" y="954095"/>
            <a:ext cx="2614850" cy="213159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D49DE10-DCE2-485C-965E-20152E4D2620}"/>
              </a:ext>
            </a:extLst>
          </p:cNvPr>
          <p:cNvSpPr/>
          <p:nvPr/>
        </p:nvSpPr>
        <p:spPr>
          <a:xfrm>
            <a:off x="6915704" y="3264730"/>
            <a:ext cx="5157927" cy="3323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finitions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“Campaigns – SIAs” includes the oral polio vaccine procurement, campaign operational costs, and campaign social mobilization costs. “Non-campaign immunization activities” include the community-based vaccination costs and others. “Surveillance” incorporates costs for laboratory, technical assistance, and other surveillance and running costs. “Core functions &amp; Infrastructure” includes ongoing quality improvements, communications, engagement, and social mobilization costs, and technical assistance. “OPV Withdrawal – SWITCH” covers research and product development as well as stockpiles for emergency response (OPV2), and technical assistance for oral polio vaccine withdrawal. </a:t>
            </a:r>
          </a:p>
          <a:p>
            <a:pPr algn="just"/>
            <a:r>
              <a:rPr lang="en-US" sz="14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ronym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OPV = oral polio vaccine; SIA = supplementary immunization activity. </a:t>
            </a:r>
          </a:p>
          <a:p>
            <a:pPr algn="just"/>
            <a:r>
              <a:rPr lang="en-US" sz="1400" b="1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urce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GPEI budget 2022 – Available at </a:t>
            </a:r>
            <a:r>
              <a:rPr lang="en-US" sz="1400" u="sng" dirty="0">
                <a:solidFill>
                  <a:srgbClr val="0000FF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polioeradication.org/</a:t>
            </a:r>
            <a:br>
              <a:rPr lang="en-US" sz="1400" u="sng" dirty="0">
                <a:solidFill>
                  <a:srgbClr val="0000FF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</a:br>
            <a:r>
              <a:rPr lang="en-US" sz="1400" u="sng" dirty="0">
                <a:solidFill>
                  <a:srgbClr val="0000FF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gpei-budget-2022/</a:t>
            </a:r>
            <a:r>
              <a:rPr lang="en-US" sz="1400" dirty="0"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data provided by GPEI). </a:t>
            </a:r>
            <a:endParaRPr lang="en-GB" sz="14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8A0A2DD-23AE-4475-B186-2702DB85DD4C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21940" y="1365885"/>
            <a:ext cx="6480000" cy="49356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954744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B671BC794A474F93336529414137EE" ma:contentTypeVersion="15" ma:contentTypeDescription="Creare un nuovo documento." ma:contentTypeScope="" ma:versionID="b03df75e6add1e186a17ac61d52fe19f">
  <xsd:schema xmlns:xsd="http://www.w3.org/2001/XMLSchema" xmlns:xs="http://www.w3.org/2001/XMLSchema" xmlns:p="http://schemas.microsoft.com/office/2006/metadata/properties" xmlns:ns2="76b97e0f-0b6c-4862-a8b7-8ef0847a5b25" xmlns:ns3="31bac29d-635b-4ff2-84e9-4347505f3004" targetNamespace="http://schemas.microsoft.com/office/2006/metadata/properties" ma:root="true" ma:fieldsID="e11bfff66511e86a94f6a0fabd31907d" ns2:_="" ns3:_="">
    <xsd:import namespace="76b97e0f-0b6c-4862-a8b7-8ef0847a5b25"/>
    <xsd:import namespace="31bac29d-635b-4ff2-84e9-4347505f300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Location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6b97e0f-0b6c-4862-a8b7-8ef0847a5b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Tag immagine" ma:readOnly="false" ma:fieldId="{5cf76f15-5ced-4ddc-b409-7134ff3c332f}" ma:taxonomyMulti="true" ma:sspId="aa4eac88-8ae6-4a96-90c7-97bc93c844e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bac29d-635b-4ff2-84e9-4347505f3004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cad81af6-b875-4386-8c2f-e831e19173c4}" ma:internalName="TaxCatchAll" ma:showField="CatchAllData" ma:web="31bac29d-635b-4ff2-84e9-4347505f300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31bac29d-635b-4ff2-84e9-4347505f3004" xsi:nil="true"/>
    <lcf76f155ced4ddcb4097134ff3c332f xmlns="76b97e0f-0b6c-4862-a8b7-8ef0847a5b2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301BFEDF-F29D-4214-B2D5-8681A87A4F54}"/>
</file>

<file path=customXml/itemProps2.xml><?xml version="1.0" encoding="utf-8"?>
<ds:datastoreItem xmlns:ds="http://schemas.openxmlformats.org/officeDocument/2006/customXml" ds:itemID="{93C156BD-F722-4FF4-A7DD-0307A91F9262}"/>
</file>

<file path=customXml/itemProps3.xml><?xml version="1.0" encoding="utf-8"?>
<ds:datastoreItem xmlns:ds="http://schemas.openxmlformats.org/officeDocument/2006/customXml" ds:itemID="{2C430E8A-845E-4EC8-BD05-1762C74A8105}"/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54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Garamond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Villa</dc:creator>
  <cp:lastModifiedBy>Simone Villa</cp:lastModifiedBy>
  <cp:revision>1</cp:revision>
  <dcterms:created xsi:type="dcterms:W3CDTF">2023-01-19T19:18:29Z</dcterms:created>
  <dcterms:modified xsi:type="dcterms:W3CDTF">2023-01-19T19:23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B671BC794A474F93336529414137EE</vt:lpwstr>
  </property>
</Properties>
</file>